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97" r:id="rId2"/>
    <p:sldId id="299" r:id="rId3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vy, Oren" initials="LO" lastIdx="22" clrIdx="0">
    <p:extLst>
      <p:ext uri="{19B8F6BF-5375-455C-9EA6-DF929625EA0E}">
        <p15:presenceInfo xmlns:p15="http://schemas.microsoft.com/office/powerpoint/2012/main" userId="Levy, Oren" providerId="None"/>
      </p:ext>
    </p:extLst>
  </p:cmAuthor>
  <p:cmAuthor id="2" name="girija goyal" initials="gg" lastIdx="8" clrIdx="1">
    <p:extLst>
      <p:ext uri="{19B8F6BF-5375-455C-9EA6-DF929625EA0E}">
        <p15:presenceInfo xmlns:p15="http://schemas.microsoft.com/office/powerpoint/2012/main" userId="3a8bc2a296b825ee" providerId="Windows Live"/>
      </p:ext>
    </p:extLst>
  </p:cmAuthor>
  <p:cmAuthor id="3" name="Girija Goyal" initials="GG" lastIdx="10" clrIdx="2">
    <p:extLst>
      <p:ext uri="{19B8F6BF-5375-455C-9EA6-DF929625EA0E}">
        <p15:presenceInfo xmlns:p15="http://schemas.microsoft.com/office/powerpoint/2012/main" userId="Girija Goya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A0A4"/>
    <a:srgbClr val="16FF16"/>
    <a:srgbClr val="7F7F7F"/>
    <a:srgbClr val="FF7C80"/>
    <a:srgbClr val="3620DA"/>
    <a:srgbClr val="4820DA"/>
    <a:srgbClr val="14093D"/>
    <a:srgbClr val="0F1137"/>
    <a:srgbClr val="0000FF"/>
    <a:srgbClr val="88168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1" autoAdjust="0"/>
    <p:restoredTop sz="89265" autoAdjust="0"/>
  </p:normalViewPr>
  <p:slideViewPr>
    <p:cSldViewPr snapToGrid="0">
      <p:cViewPr varScale="1">
        <p:scale>
          <a:sx n="49" d="100"/>
          <a:sy n="49" d="100"/>
        </p:scale>
        <p:origin x="2008" y="2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E0C9F4C-611C-4939-B37C-EBADF52E7491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A31E924-C22A-4937-892D-17E474D8538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76544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0764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4776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9707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06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0490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8341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4108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4525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9836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9292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2026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13103-2837-441F-8AC4-73F8B481B70C}" type="datetimeFigureOut">
              <a:rPr lang="en-US" smtClean="0"/>
              <a:t>11/25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2D8CD-11E5-4E42-86C2-EE34C21389B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508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6BC768C-4EC8-4DDA-9160-83DC0DB1C610}"/>
              </a:ext>
            </a:extLst>
          </p:cNvPr>
          <p:cNvSpPr txBox="1"/>
          <p:nvPr/>
        </p:nvSpPr>
        <p:spPr>
          <a:xfrm>
            <a:off x="118771" y="1698915"/>
            <a:ext cx="67785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US" sz="2400" b="1" dirty="0"/>
          </a:p>
          <a:p>
            <a:pPr algn="ctr"/>
            <a:r>
              <a:rPr lang="en-US" sz="2400" b="1" dirty="0"/>
              <a:t>Clinical Samples used in this Study</a:t>
            </a:r>
            <a:endParaRPr lang="en-US" sz="24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2228791"/>
              </p:ext>
            </p:extLst>
          </p:nvPr>
        </p:nvGraphicFramePr>
        <p:xfrm>
          <a:off x="556052" y="2743200"/>
          <a:ext cx="5903964" cy="282969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75991">
                  <a:extLst>
                    <a:ext uri="{9D8B030D-6E8A-4147-A177-3AD203B41FA5}">
                      <a16:colId xmlns:a16="http://schemas.microsoft.com/office/drawing/2014/main" val="1221902533"/>
                    </a:ext>
                  </a:extLst>
                </a:gridCol>
                <a:gridCol w="1475991">
                  <a:extLst>
                    <a:ext uri="{9D8B030D-6E8A-4147-A177-3AD203B41FA5}">
                      <a16:colId xmlns:a16="http://schemas.microsoft.com/office/drawing/2014/main" val="2652460168"/>
                    </a:ext>
                  </a:extLst>
                </a:gridCol>
                <a:gridCol w="1475991">
                  <a:extLst>
                    <a:ext uri="{9D8B030D-6E8A-4147-A177-3AD203B41FA5}">
                      <a16:colId xmlns:a16="http://schemas.microsoft.com/office/drawing/2014/main" val="3166247986"/>
                    </a:ext>
                  </a:extLst>
                </a:gridCol>
                <a:gridCol w="1475991">
                  <a:extLst>
                    <a:ext uri="{9D8B030D-6E8A-4147-A177-3AD203B41FA5}">
                      <a16:colId xmlns:a16="http://schemas.microsoft.com/office/drawing/2014/main" val="3742922294"/>
                    </a:ext>
                  </a:extLst>
                </a:gridCol>
              </a:tblGrid>
              <a:tr h="48575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sample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ed for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ure numbers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245954114"/>
                  </a:ext>
                </a:extLst>
              </a:tr>
              <a:tr h="48575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MC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arded apheresis collar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chip, 2D and static 3D studie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686811781"/>
                  </a:ext>
                </a:extLst>
              </a:tr>
              <a:tr h="48575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sil Single cell suspension 1</a:t>
                      </a:r>
                    </a:p>
                  </a:txBody>
                  <a:tcPr marL="6350" marR="6350" marT="6350" marB="0" anchor="b"/>
                </a:tc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arded tonsil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used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. Fig. 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01131053"/>
                  </a:ext>
                </a:extLst>
              </a:tr>
              <a:tr h="48575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sil Single cell suspension 2</a:t>
                      </a:r>
                    </a:p>
                  </a:txBody>
                  <a:tcPr marL="6350" marR="6350" marT="6350" marB="0" anchor="b"/>
                </a:tc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rator for influenza antibodie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 5a,b d and Sup. Fig. 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71412061"/>
                  </a:ext>
                </a:extLst>
              </a:tr>
              <a:tr h="88667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um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um of consented volunteer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re chip cytokine changes to clinical cytokine changes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 5g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70553082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3D3134D-FF8A-B941-B988-563E1F924C3D}"/>
              </a:ext>
            </a:extLst>
          </p:cNvPr>
          <p:cNvSpPr txBox="1"/>
          <p:nvPr/>
        </p:nvSpPr>
        <p:spPr>
          <a:xfrm>
            <a:off x="3352049" y="8524220"/>
            <a:ext cx="310796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Supplementary Table 1</a:t>
            </a: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33146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6BC768C-4EC8-4DDA-9160-83DC0DB1C610}"/>
              </a:ext>
            </a:extLst>
          </p:cNvPr>
          <p:cNvSpPr txBox="1"/>
          <p:nvPr/>
        </p:nvSpPr>
        <p:spPr>
          <a:xfrm>
            <a:off x="-318509" y="693075"/>
            <a:ext cx="67785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sz="2400" b="1" dirty="0"/>
          </a:p>
          <a:p>
            <a:pPr algn="ctr"/>
            <a:r>
              <a:rPr lang="en-US" sz="2400" b="1" dirty="0"/>
              <a:t>Summary of Culture Systems and Results</a:t>
            </a:r>
            <a:endParaRPr lang="en-US" sz="24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0933596"/>
              </p:ext>
            </p:extLst>
          </p:nvPr>
        </p:nvGraphicFramePr>
        <p:xfrm>
          <a:off x="469557" y="1621951"/>
          <a:ext cx="5990459" cy="63838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9816">
                  <a:extLst>
                    <a:ext uri="{9D8B030D-6E8A-4147-A177-3AD203B41FA5}">
                      <a16:colId xmlns:a16="http://schemas.microsoft.com/office/drawing/2014/main" val="181187669"/>
                    </a:ext>
                  </a:extLst>
                </a:gridCol>
                <a:gridCol w="1025611">
                  <a:extLst>
                    <a:ext uri="{9D8B030D-6E8A-4147-A177-3AD203B41FA5}">
                      <a16:colId xmlns:a16="http://schemas.microsoft.com/office/drawing/2014/main" val="2031774184"/>
                    </a:ext>
                  </a:extLst>
                </a:gridCol>
                <a:gridCol w="1309816">
                  <a:extLst>
                    <a:ext uri="{9D8B030D-6E8A-4147-A177-3AD203B41FA5}">
                      <a16:colId xmlns:a16="http://schemas.microsoft.com/office/drawing/2014/main" val="4283802245"/>
                    </a:ext>
                  </a:extLst>
                </a:gridCol>
                <a:gridCol w="840259">
                  <a:extLst>
                    <a:ext uri="{9D8B030D-6E8A-4147-A177-3AD203B41FA5}">
                      <a16:colId xmlns:a16="http://schemas.microsoft.com/office/drawing/2014/main" val="2018311350"/>
                    </a:ext>
                  </a:extLst>
                </a:gridCol>
                <a:gridCol w="1037968">
                  <a:extLst>
                    <a:ext uri="{9D8B030D-6E8A-4147-A177-3AD203B41FA5}">
                      <a16:colId xmlns:a16="http://schemas.microsoft.com/office/drawing/2014/main" val="62624478"/>
                    </a:ext>
                  </a:extLst>
                </a:gridCol>
                <a:gridCol w="466989">
                  <a:extLst>
                    <a:ext uri="{9D8B030D-6E8A-4147-A177-3AD203B41FA5}">
                      <a16:colId xmlns:a16="http://schemas.microsoft.com/office/drawing/2014/main" val="129225566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timul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tatic 3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uman LF Chi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Fig</a:t>
                      </a:r>
                      <a:r>
                        <a:rPr lang="en-US" baseline="0" dirty="0"/>
                        <a:t> #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84045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5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ell density &amp; EC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35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onventional</a:t>
                      </a:r>
                    </a:p>
                    <a:p>
                      <a:pPr algn="l" fontAlgn="b"/>
                      <a:r>
                        <a:rPr lang="en-US" sz="13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2.25</a:t>
                      </a:r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 – 3 X10</a:t>
                      </a:r>
                      <a:r>
                        <a:rPr lang="en-US" sz="135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l" fontAlgn="b"/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In 24 well plate</a:t>
                      </a:r>
                    </a:p>
                    <a:p>
                      <a:pPr algn="l" fontAlgn="b"/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96cm</a:t>
                      </a:r>
                      <a:r>
                        <a:rPr lang="en-US" sz="135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2</a:t>
                      </a:r>
                      <a:endParaRPr lang="en-US" sz="135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pPr algn="l" fontAlgn="b"/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No ECM</a:t>
                      </a:r>
                      <a:endParaRPr lang="en-US" sz="13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3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High</a:t>
                      </a:r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 density</a:t>
                      </a:r>
                    </a:p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2.25</a:t>
                      </a:r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 – 3 X10</a:t>
                      </a:r>
                      <a:r>
                        <a:rPr lang="en-US" sz="135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l" fontAlgn="b"/>
                      <a:r>
                        <a:rPr lang="en-US" sz="135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in</a:t>
                      </a:r>
                      <a:r>
                        <a:rPr lang="en-US" sz="13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 15ul of ECM gel</a:t>
                      </a:r>
                      <a:endParaRPr lang="en-US" sz="135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  <a:p>
                      <a:endParaRPr lang="en-US" sz="1350" dirty="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90476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Follicl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/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28963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T cell polariz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5782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CXCL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+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, S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09971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A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4,</a:t>
                      </a:r>
                      <a:r>
                        <a:rPr lang="en-US" baseline="0" dirty="0"/>
                        <a:t> 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64472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B cell autoactivation</a:t>
                      </a:r>
                    </a:p>
                    <a:p>
                      <a:r>
                        <a:rPr lang="en-US" b="1" dirty="0"/>
                        <a:t>(CD27, Ig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rgbClr val="FF0000"/>
                          </a:solidFill>
                        </a:rPr>
                        <a:t>Y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rgbClr val="FF0000"/>
                          </a:solidFill>
                        </a:rPr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29473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CD138+</a:t>
                      </a:r>
                      <a:r>
                        <a:rPr lang="en-US" b="1" baseline="0" dirty="0"/>
                        <a:t> cells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aseline="0" dirty="0"/>
                        <a:t>SAC or IL4+</a:t>
                      </a:r>
                      <a:r>
                        <a:rPr lang="el-GR" baseline="0" dirty="0"/>
                        <a:t>α</a:t>
                      </a:r>
                      <a:r>
                        <a:rPr lang="en-US" baseline="0" dirty="0"/>
                        <a:t>CD4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ot done</a:t>
                      </a:r>
                    </a:p>
                  </a:txBody>
                  <a:tcPr/>
                </a:tc>
                <a:tc rowSpan="7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Not done</a:t>
                      </a:r>
                    </a:p>
                    <a:p>
                      <a:endParaRPr lang="en-US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Y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89967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Anti-HA</a:t>
                      </a:r>
                      <a:r>
                        <a:rPr lang="en-US" b="1" baseline="0" dirty="0"/>
                        <a:t> IgG</a:t>
                      </a:r>
                      <a:endParaRPr lang="en-US" b="1" dirty="0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aseline="0" dirty="0"/>
                        <a:t>low dose inactive H5N1 and SWE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+/-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5501078"/>
                  </a:ext>
                </a:extLst>
              </a:tr>
              <a:tr h="428413"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CD138+</a:t>
                      </a:r>
                      <a:r>
                        <a:rPr lang="en-US" b="1" baseline="0" dirty="0"/>
                        <a:t> cells</a:t>
                      </a:r>
                      <a:endParaRPr lang="en-US" b="1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5">
                  <a:txBody>
                    <a:bodyPr/>
                    <a:lstStyle/>
                    <a:p>
                      <a:r>
                        <a:rPr lang="en-US" dirty="0"/>
                        <a:t>Not done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b="1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 rowSpan="5">
                  <a:txBody>
                    <a:bodyPr/>
                    <a:lstStyle/>
                    <a:p>
                      <a:r>
                        <a:rPr lang="en-US" b="0" dirty="0">
                          <a:solidFill>
                            <a:schemeClr val="tx1"/>
                          </a:solidFill>
                        </a:rPr>
                        <a:t>Y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440336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dirty="0"/>
                        <a:t>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8423269"/>
                  </a:ext>
                </a:extLst>
              </a:tr>
              <a:tr h="313267"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Anti-HA</a:t>
                      </a:r>
                      <a:r>
                        <a:rPr lang="en-US" b="1" baseline="0" dirty="0"/>
                        <a:t> IgG</a:t>
                      </a:r>
                      <a:endParaRPr lang="en-US" b="1" dirty="0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Trivalent Fluzone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b="1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2720598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dirty="0"/>
                        <a:t>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70259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Cytokines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b="1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395398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06DF44F-0520-1F4B-818E-E359BBF846A4}"/>
              </a:ext>
            </a:extLst>
          </p:cNvPr>
          <p:cNvSpPr txBox="1"/>
          <p:nvPr/>
        </p:nvSpPr>
        <p:spPr>
          <a:xfrm>
            <a:off x="3352049" y="8524220"/>
            <a:ext cx="310796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Supplementary Table 2</a:t>
            </a: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9843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2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27</TotalTime>
  <Words>204</Words>
  <Application>Microsoft Office PowerPoint</Application>
  <PresentationFormat>Letter Paper (8.5x11 in)</PresentationFormat>
  <Paragraphs>8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rija Goyal</dc:creator>
  <cp:lastModifiedBy>Goyal, Girija</cp:lastModifiedBy>
  <cp:revision>629</cp:revision>
  <cp:lastPrinted>2018-06-25T17:27:11Z</cp:lastPrinted>
  <dcterms:created xsi:type="dcterms:W3CDTF">2018-05-31T19:45:26Z</dcterms:created>
  <dcterms:modified xsi:type="dcterms:W3CDTF">2021-11-26T02:34:09Z</dcterms:modified>
</cp:coreProperties>
</file>